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35600" cy="9867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-36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14560" y="-36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981080" y="739440"/>
            <a:ext cx="2773440" cy="3700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2840" y="4686120"/>
            <a:ext cx="5389560" cy="4439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37080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14560" y="9370800"/>
            <a:ext cx="2919240" cy="49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D8BC23-5D18-49D4-9421-8E6DFBB787A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sldImg"/>
          </p:nvPr>
        </p:nvSpPr>
        <p:spPr>
          <a:xfrm>
            <a:off x="1981080" y="739800"/>
            <a:ext cx="2773440" cy="3700440"/>
          </a:xfrm>
          <a:prstGeom prst="rect">
            <a:avLst/>
          </a:prstGeom>
          <a:ln w="0">
            <a:noFill/>
          </a:ln>
        </p:spPr>
      </p:sp>
      <p:sp>
        <p:nvSpPr>
          <p:cNvPr id="77" name="PlaceHolder 2"/>
          <p:cNvSpPr>
            <a:spLocks noGrp="1"/>
          </p:cNvSpPr>
          <p:nvPr>
            <p:ph type="body"/>
          </p:nvPr>
        </p:nvSpPr>
        <p:spPr>
          <a:xfrm>
            <a:off x="672840" y="4686120"/>
            <a:ext cx="5389560" cy="443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Slide Number Placeholder 3"/>
          <p:cNvSpPr/>
          <p:nvPr/>
        </p:nvSpPr>
        <p:spPr>
          <a:xfrm>
            <a:off x="3814920" y="937116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EEB3B7-F29F-44F9-B221-9CAAA305EAF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9FB481-ECA0-4BE6-B671-CC8C2CFF937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010273-E24D-4C7F-97D7-00110DA0D6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8FB031-47D9-4D34-96C1-B1C22D0A002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DAE27F-24F0-4EAA-94F2-3DCA7713498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BD8037-80F2-4A0E-A092-7ED910EB54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67DDA1-FE52-42AC-929E-2131E1AE0E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3697D6-EFC3-463E-855C-8796C29180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4FE0A7-8D73-4A8F-9181-A57811DB4F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F07340-30D6-408C-B052-68F5D51FBF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1A7343-2B05-49D3-9DD1-D228FB6776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F9EAD5-017B-4927-8ACF-5138A77D31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7BA319-2732-4E2D-8887-8703684F9F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569B2E9-3AE3-4D8E-A383-86887E85CE6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2"/>
          <p:cNvSpPr/>
          <p:nvPr/>
        </p:nvSpPr>
        <p:spPr>
          <a:xfrm>
            <a:off x="315360" y="334800"/>
            <a:ext cx="1721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Additional Fil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Group 13"/>
          <p:cNvGrpSpPr/>
          <p:nvPr/>
        </p:nvGrpSpPr>
        <p:grpSpPr>
          <a:xfrm>
            <a:off x="606600" y="1411200"/>
            <a:ext cx="5538600" cy="2513160"/>
            <a:chOff x="606600" y="1411200"/>
            <a:chExt cx="5538600" cy="2513160"/>
          </a:xfrm>
        </p:grpSpPr>
        <p:sp>
          <p:nvSpPr>
            <p:cNvPr id="50" name="TextBox 42"/>
            <p:cNvSpPr/>
            <p:nvPr/>
          </p:nvSpPr>
          <p:spPr>
            <a:xfrm>
              <a:off x="606600" y="2360160"/>
              <a:ext cx="734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sv-S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AM1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"/>
            <p:cNvSpPr/>
            <p:nvPr/>
          </p:nvSpPr>
          <p:spPr>
            <a:xfrm>
              <a:off x="1844640" y="2274840"/>
              <a:ext cx="1008000" cy="106200"/>
            </a:xfrm>
            <a:prstGeom prst="rect">
              <a:avLst/>
            </a:prstGeom>
            <a:noFill/>
            <a:ln w="9360">
              <a:solidFill>
                <a:srgbClr val="4a7ebb"/>
              </a:solidFill>
              <a:miter/>
            </a:ln>
            <a:effectLst>
              <a:outerShdw dist="23040" dir="5400000" blurRad="0" rotWithShape="0">
                <a:srgbClr val="80808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42"/>
            <p:cNvSpPr/>
            <p:nvPr/>
          </p:nvSpPr>
          <p:spPr>
            <a:xfrm>
              <a:off x="606600" y="1990800"/>
              <a:ext cx="820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sv-S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AM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42"/>
            <p:cNvSpPr/>
            <p:nvPr/>
          </p:nvSpPr>
          <p:spPr>
            <a:xfrm>
              <a:off x="606600" y="2156760"/>
              <a:ext cx="81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sv-S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AM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42"/>
            <p:cNvSpPr/>
            <p:nvPr/>
          </p:nvSpPr>
          <p:spPr>
            <a:xfrm>
              <a:off x="606600" y="2550600"/>
              <a:ext cx="87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sv-S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S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42"/>
            <p:cNvSpPr/>
            <p:nvPr/>
          </p:nvSpPr>
          <p:spPr>
            <a:xfrm>
              <a:off x="606600" y="2749320"/>
              <a:ext cx="696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sv-S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TS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42"/>
            <p:cNvSpPr/>
            <p:nvPr/>
          </p:nvSpPr>
          <p:spPr>
            <a:xfrm>
              <a:off x="606600" y="2904480"/>
              <a:ext cx="77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sv-S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LAU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7" name="Group 12"/>
            <p:cNvGrpSpPr/>
            <p:nvPr/>
          </p:nvGrpSpPr>
          <p:grpSpPr>
            <a:xfrm>
              <a:off x="1270800" y="1411200"/>
              <a:ext cx="4126680" cy="2513160"/>
              <a:chOff x="1270800" y="1411200"/>
              <a:chExt cx="4126680" cy="2513160"/>
            </a:xfrm>
          </p:grpSpPr>
          <p:grpSp>
            <p:nvGrpSpPr>
              <p:cNvPr id="58" name="Group 11"/>
              <p:cNvGrpSpPr/>
              <p:nvPr/>
            </p:nvGrpSpPr>
            <p:grpSpPr>
              <a:xfrm>
                <a:off x="1270800" y="1411200"/>
                <a:ext cx="4126680" cy="2513160"/>
                <a:chOff x="1270800" y="1411200"/>
                <a:chExt cx="4126680" cy="2513160"/>
              </a:xfrm>
            </p:grpSpPr>
            <p:grpSp>
              <p:nvGrpSpPr>
                <p:cNvPr id="59" name="Group 7"/>
                <p:cNvGrpSpPr/>
                <p:nvPr/>
              </p:nvGrpSpPr>
              <p:grpSpPr>
                <a:xfrm>
                  <a:off x="1270800" y="1411200"/>
                  <a:ext cx="4126680" cy="2513160"/>
                  <a:chOff x="1270800" y="1411200"/>
                  <a:chExt cx="4126680" cy="2513160"/>
                </a:xfrm>
              </p:grpSpPr>
              <p:grpSp>
                <p:nvGrpSpPr>
                  <p:cNvPr id="60" name="Group 6"/>
                  <p:cNvGrpSpPr/>
                  <p:nvPr/>
                </p:nvGrpSpPr>
                <p:grpSpPr>
                  <a:xfrm>
                    <a:off x="1270800" y="1411200"/>
                    <a:ext cx="4126680" cy="2513160"/>
                    <a:chOff x="1270800" y="1411200"/>
                    <a:chExt cx="4126680" cy="2513160"/>
                  </a:xfrm>
                </p:grpSpPr>
                <p:pic>
                  <p:nvPicPr>
                    <p:cNvPr id="61" name="Picture 4" descr=""/>
                    <p:cNvPicPr/>
                    <p:nvPr/>
                  </p:nvPicPr>
                  <p:blipFill>
                    <a:blip r:embed="rId1"/>
                    <a:srcRect l="14948" t="0" r="13764" b="0"/>
                    <a:stretch/>
                  </p:blipFill>
                  <p:spPr>
                    <a:xfrm>
                      <a:off x="1270800" y="1698840"/>
                      <a:ext cx="4126680" cy="22255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sp>
                  <p:nvSpPr>
                    <p:cNvPr id="62" name="TextBox 42"/>
                    <p:cNvSpPr/>
                    <p:nvPr/>
                  </p:nvSpPr>
                  <p:spPr>
                    <a:xfrm>
                      <a:off x="1562400" y="1411200"/>
                      <a:ext cx="1450080" cy="307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K-RasGV12/ E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3" name="TextBox 44"/>
                    <p:cNvSpPr/>
                    <p:nvPr/>
                  </p:nvSpPr>
                  <p:spPr>
                    <a:xfrm>
                      <a:off x="3566160" y="1411200"/>
                      <a:ext cx="1736640" cy="3070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sv-SE" sz="14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K-RasGV12/ E1-R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64" name="Straight Connector 3"/>
                  <p:cNvSpPr/>
                  <p:nvPr/>
                </p:nvSpPr>
                <p:spPr>
                  <a:xfrm>
                    <a:off x="3633840" y="1758600"/>
                    <a:ext cx="1649160" cy="1440"/>
                  </a:xfrm>
                  <a:prstGeom prst="line">
                    <a:avLst/>
                  </a:prstGeom>
                  <a:ln w="9360">
                    <a:solidFill>
                      <a:srgbClr val="40404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65" name="Straight Connector 39"/>
                <p:cNvSpPr/>
                <p:nvPr/>
              </p:nvSpPr>
              <p:spPr>
                <a:xfrm>
                  <a:off x="1490760" y="1758600"/>
                  <a:ext cx="1649160" cy="1440"/>
                </a:xfrm>
                <a:prstGeom prst="line">
                  <a:avLst/>
                </a:prstGeom>
                <a:ln w="9360">
                  <a:solidFill>
                    <a:srgbClr val="40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Straight Connector 40"/>
                <p:cNvSpPr/>
                <p:nvPr/>
              </p:nvSpPr>
              <p:spPr>
                <a:xfrm>
                  <a:off x="1484280" y="3902400"/>
                  <a:ext cx="1649160" cy="1440"/>
                </a:xfrm>
                <a:prstGeom prst="line">
                  <a:avLst/>
                </a:prstGeom>
                <a:ln w="9360">
                  <a:solidFill>
                    <a:srgbClr val="40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Straight Connector 42"/>
                <p:cNvSpPr/>
                <p:nvPr/>
              </p:nvSpPr>
              <p:spPr>
                <a:xfrm>
                  <a:off x="1485720" y="1753920"/>
                  <a:ext cx="0" cy="2144880"/>
                </a:xfrm>
                <a:prstGeom prst="line">
                  <a:avLst/>
                </a:prstGeom>
                <a:ln w="9360">
                  <a:solidFill>
                    <a:srgbClr val="40404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8" name="TextBox 42"/>
              <p:cNvSpPr/>
              <p:nvPr/>
            </p:nvSpPr>
            <p:spPr>
              <a:xfrm>
                <a:off x="3156480" y="2853000"/>
                <a:ext cx="450720" cy="2462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sv-S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FP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9" name="TextBox 42"/>
            <p:cNvSpPr/>
            <p:nvPr/>
          </p:nvSpPr>
          <p:spPr>
            <a:xfrm>
              <a:off x="5373360" y="3024720"/>
              <a:ext cx="77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sv-S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SP 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42"/>
            <p:cNvSpPr/>
            <p:nvPr/>
          </p:nvSpPr>
          <p:spPr>
            <a:xfrm>
              <a:off x="5373360" y="3181320"/>
              <a:ext cx="77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sv-S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SP 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42"/>
            <p:cNvSpPr/>
            <p:nvPr/>
          </p:nvSpPr>
          <p:spPr>
            <a:xfrm>
              <a:off x="5373360" y="3421440"/>
              <a:ext cx="77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sv-S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SP 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42"/>
            <p:cNvSpPr/>
            <p:nvPr/>
          </p:nvSpPr>
          <p:spPr>
            <a:xfrm>
              <a:off x="5373360" y="3672720"/>
              <a:ext cx="77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sv-SE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T1-MM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3" name="TextBox 3"/>
          <p:cNvSpPr/>
          <p:nvPr/>
        </p:nvSpPr>
        <p:spPr>
          <a:xfrm>
            <a:off x="322200" y="1015920"/>
            <a:ext cx="3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3"/>
          <p:cNvSpPr/>
          <p:nvPr/>
        </p:nvSpPr>
        <p:spPr>
          <a:xfrm>
            <a:off x="330480" y="450864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5" name="Picture 5" descr=""/>
          <p:cNvPicPr/>
          <p:nvPr/>
        </p:nvPicPr>
        <p:blipFill>
          <a:blip r:embed="rId2"/>
          <a:stretch/>
        </p:blipFill>
        <p:spPr>
          <a:xfrm>
            <a:off x="309600" y="4805280"/>
            <a:ext cx="6432480" cy="990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08T10:41:45Z</dcterms:created>
  <dc:creator>Martin Augsten</dc:creator>
  <dc:description/>
  <dc:language>en-US</dc:language>
  <cp:lastModifiedBy>cdomile</cp:lastModifiedBy>
  <cp:lastPrinted>2013-08-23T21:15:24Z</cp:lastPrinted>
  <dcterms:modified xsi:type="dcterms:W3CDTF">2014-01-16T17:02:04Z</dcterms:modified>
  <cp:revision>77</cp:revision>
  <dc:subject/>
  <dc:title>Slide 1</dc:title>
</cp:coreProperties>
</file>